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9" r:id="rId3"/>
    <p:sldId id="270" r:id="rId4"/>
    <p:sldId id="261" r:id="rId5"/>
    <p:sldId id="262" r:id="rId6"/>
    <p:sldId id="263" r:id="rId7"/>
    <p:sldId id="273" r:id="rId8"/>
    <p:sldId id="274" r:id="rId9"/>
    <p:sldId id="281" r:id="rId10"/>
    <p:sldId id="278" r:id="rId11"/>
    <p:sldId id="279" r:id="rId12"/>
    <p:sldId id="280" r:id="rId13"/>
  </p:sldIdLst>
  <p:sldSz cx="9144000" cy="6858000" type="screen4x3"/>
  <p:notesSz cx="6858000" cy="9144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63" d="100"/>
          <a:sy n="63" d="100"/>
        </p:scale>
        <p:origin x="1308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Subtíto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a-ES" smtClean="0"/>
              <a:t>Feu clic aquí per editar l'estil de subtítols del patró.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934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1908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4095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6007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3499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contingut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35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5" name="Contenidor de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6" name="Contenidor de contingut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7" name="Contenidor de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8" name="Contenidor de peu de pà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4292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4" name="Contenidor de peu de pà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508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3" name="Contenidor de peu de pà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4268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3323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'imatg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a-ES" smtClean="0"/>
              <a:t>Feu clic aquí per editar estils</a:t>
            </a:r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8729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 smtClean="0"/>
              <a:t>Feu clic aquí per editar l'estil</a:t>
            </a:r>
            <a:endParaRPr lang="es-E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 smtClean="0"/>
              <a:t>Feu clic aquí per editar estils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s-E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E0C67-00AD-4B51-B524-E733AA54A2CD}" type="datetimeFigureOut">
              <a:rPr lang="es-ES" smtClean="0"/>
              <a:t>03/10/2019</a:t>
            </a:fld>
            <a:endParaRPr lang="es-E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8E8662-EA0A-4A6A-8EA6-07CB758C2B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14750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9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9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9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9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9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9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9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9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9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9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9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9" r="6472"/>
          <a:stretch/>
        </p:blipFill>
        <p:spPr>
          <a:xfrm>
            <a:off x="1280160" y="1371600"/>
            <a:ext cx="658368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ause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2248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" r="6756"/>
          <a:stretch/>
        </p:blipFill>
        <p:spPr>
          <a:xfrm>
            <a:off x="1275080" y="1371600"/>
            <a:ext cx="659384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marke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HF admission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4123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" r="7324"/>
          <a:stretch/>
        </p:blipFill>
        <p:spPr>
          <a:xfrm>
            <a:off x="1290320" y="1371600"/>
            <a:ext cx="656336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HF admission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1729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" r="6898"/>
          <a:stretch/>
        </p:blipFill>
        <p:spPr>
          <a:xfrm>
            <a:off x="1280160" y="1371600"/>
            <a:ext cx="658368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HF admission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3818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5" r="6898"/>
          <a:stretch/>
        </p:blipFill>
        <p:spPr>
          <a:xfrm>
            <a:off x="1285240" y="1371600"/>
            <a:ext cx="657352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ause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33297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9" r="7465"/>
          <a:stretch/>
        </p:blipFill>
        <p:spPr>
          <a:xfrm>
            <a:off x="1315720" y="1371600"/>
            <a:ext cx="651256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ause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6937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" r="6614"/>
          <a:stretch/>
        </p:blipFill>
        <p:spPr>
          <a:xfrm>
            <a:off x="1290320" y="1371600"/>
            <a:ext cx="656336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cardiovascula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0200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" r="6898"/>
          <a:stretch/>
        </p:blipFill>
        <p:spPr>
          <a:xfrm>
            <a:off x="1305560" y="1371600"/>
            <a:ext cx="653288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cardiovascula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12902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6" r="6471"/>
          <a:stretch/>
        </p:blipFill>
        <p:spPr>
          <a:xfrm>
            <a:off x="1295400" y="1371600"/>
            <a:ext cx="6553200" cy="4114800"/>
          </a:xfrm>
        </p:spPr>
      </p:pic>
      <p:sp>
        <p:nvSpPr>
          <p:cNvPr id="8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cardiovascula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7601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2" r="7324"/>
          <a:stretch/>
        </p:blipFill>
        <p:spPr>
          <a:xfrm>
            <a:off x="1320800" y="1371600"/>
            <a:ext cx="650240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HF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20674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" r="7465"/>
          <a:stretch/>
        </p:blipFill>
        <p:spPr>
          <a:xfrm>
            <a:off x="1325880" y="1371600"/>
            <a:ext cx="6492240" cy="4114800"/>
          </a:xfrm>
        </p:spPr>
      </p:pic>
      <p:sp>
        <p:nvSpPr>
          <p:cNvPr id="8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HF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75526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idor d'imatge 4"/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9" r="6614"/>
          <a:stretch/>
        </p:blipFill>
        <p:spPr>
          <a:xfrm>
            <a:off x="1285240" y="1371600"/>
            <a:ext cx="6573520" cy="4114800"/>
          </a:xfrm>
        </p:spPr>
      </p:pic>
      <p:sp>
        <p:nvSpPr>
          <p:cNvPr id="6" name="Títol 1"/>
          <p:cNvSpPr txBox="1">
            <a:spLocks/>
          </p:cNvSpPr>
          <p:nvPr/>
        </p:nvSpPr>
        <p:spPr>
          <a:xfrm>
            <a:off x="1828800" y="836712"/>
            <a:ext cx="5486400" cy="35416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0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-biomarker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-month HF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7826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73</Words>
  <Application>Microsoft Office PowerPoint</Application>
  <PresentationFormat>Presentación en pantalla (4:3)</PresentationFormat>
  <Paragraphs>12</Paragraphs>
  <Slides>1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2</vt:i4>
      </vt:variant>
    </vt:vector>
  </HeadingPairs>
  <TitlesOfParts>
    <vt:vector size="16" baseType="lpstr">
      <vt:lpstr>Arial</vt:lpstr>
      <vt:lpstr>Calibri</vt:lpstr>
      <vt:lpstr>Times New Roman</vt:lpstr>
      <vt:lpstr>Tema de l'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Andreu Ferrero Gregori</dc:creator>
  <cp:lastModifiedBy>Jesús Álvarez García</cp:lastModifiedBy>
  <cp:revision>40</cp:revision>
  <dcterms:created xsi:type="dcterms:W3CDTF">2019-01-25T08:29:29Z</dcterms:created>
  <dcterms:modified xsi:type="dcterms:W3CDTF">2019-10-03T18:41:23Z</dcterms:modified>
</cp:coreProperties>
</file>